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77545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3C8D8-E8D7-455E-BD5C-1752CE0D1F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AF50E-EC9F-454D-A44A-FD17EEF3C0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B65F5-CF37-43CF-BC14-B4323AD021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7872D-E868-492C-893A-909E0CBCC7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68A074-34A5-47D1-A1C4-DF01AFD4CA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9C188-D1C7-4AFE-977E-BD7430DE41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1DB08-2153-45E9-8509-7633BB2A5C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5681F-004C-43B3-B3E5-8120D1C9D5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23BDF-4EF9-4BBA-89FF-742FD50B5E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8C3AE-DE3E-4636-B77C-829BD05182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BF66E-7309-46DF-8589-73D1B126D3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78CFC-B230-4249-8782-90C608A063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513C88-D1DF-4924-AC00-D4E1CCE9D8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3360" y="77803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33360" y="56847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33360" y="16477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3360" y="184320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33360" y="23670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3360" y="27162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33360" y="30654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33360" y="35892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33360" y="393876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3360" y="428796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33360" y="46371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33360" y="14763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3360" y="20178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33360" y="25416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33360" y="28908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33360" y="32400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33360" y="37638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33360" y="411336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33360" y="44625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3360" y="48117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3360" y="53355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33360" y="58593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33360" y="62085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33360" y="655812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33360" y="70819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33360" y="74311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33360" y="51609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33360" y="55101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33360" y="60339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33360" y="63831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33360" y="690732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33360" y="72565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33360" y="76057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351320" y="670860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351320" y="65358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32160" y="65358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.75 ± 2.47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647720" y="6535800"/>
            <a:ext cx="14652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120N,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351320" y="63612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332160" y="63612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.23 ± 3.29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647720" y="636120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I151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351320" y="61866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332160" y="61866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31 ± 1.9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647720" y="618660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351320" y="60120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332160" y="60120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.75 ± 2.2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647720" y="601200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120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136600" y="6708600"/>
            <a:ext cx="48744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332160" y="670860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105440" y="667692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603760" y="65358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74.5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603760" y="63612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23.0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603760" y="61866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31.0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603760" y="60120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75.8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603760" y="67104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603760" y="60120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332160" y="60120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647720" y="5837400"/>
            <a:ext cx="488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603760" y="56642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9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351320" y="566244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.95 ± 1.3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332160" y="566244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.83 ± 0.8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647720" y="5662440"/>
            <a:ext cx="14652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Q192H,S235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603760" y="54896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1.2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351320" y="548784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56 ± 0.1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351320" y="60120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ＭＳ Ｐゴシック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332160" y="548784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.33 ± 1.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647720" y="548784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235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603760" y="53150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0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351320" y="53150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.22 ± 0.73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332160" y="53150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.94 ± 2.6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647720" y="531504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Q192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632560" y="5140440"/>
            <a:ext cx="576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458.2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379760" y="51404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&lt;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360600" y="51404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4.58 ± 3.65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136600" y="4965840"/>
            <a:ext cx="4874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623960" y="5140440"/>
            <a:ext cx="66348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rEG/D1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603760" y="49658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351320" y="49658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332160" y="49658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603760" y="47912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9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351320" y="47912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81 ± 0.6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332160" y="47912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.03 ± 4.3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647720" y="479124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5603760" y="461628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351320" y="461628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41 ± 1.47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332160" y="461628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18 ± 2.9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647720" y="461628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603760" y="444348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6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351320" y="444168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84 ± 0.3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332160" y="444168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37 ± 1.5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647720" y="444168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482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5603760" y="426888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2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351320" y="426708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.74 ± 1.9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332160" y="426708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.55 ± 3.2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647720" y="426708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603760" y="409428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69.0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351320" y="409428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332160" y="409428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.69 ± 5.1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647720" y="409428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603760" y="391968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24.0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4351320" y="391968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332160" y="391968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.24 ± 4.95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647720" y="391968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5603760" y="374508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58.7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351320" y="374508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332160" y="374508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.59 ± 1.2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647720" y="374508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603760" y="357012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58.2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351320" y="357012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332160" y="357012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.58 ± 3.6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647720" y="3570120"/>
            <a:ext cx="48888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603760" y="33973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351320" y="339552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332160" y="339552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47560" y="357012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combinant vir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5603760" y="32227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3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351320" y="322092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.48 ± 1.94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332160" y="322092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.45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±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8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647720" y="3220920"/>
            <a:ext cx="48888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5603760" y="30481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43.2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351320" y="304632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332160" y="304632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43 ± 2.08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647720" y="3046320"/>
            <a:ext cx="488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5603760" y="28735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51.9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351320" y="287352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332160" y="287352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52 ± 4.6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647720" y="2873520"/>
            <a:ext cx="488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2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603760" y="26989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89.4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4351320" y="269892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332160" y="269892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89 ± 2.51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647720" y="2698920"/>
            <a:ext cx="488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5603760" y="252396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28.6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351320" y="252396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332160" y="252396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29 ± 0.6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647720" y="2523960"/>
            <a:ext cx="48888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5603760" y="234936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32.1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351320" y="234936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332160" y="234936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.32 ± 1.8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647720" y="2349360"/>
            <a:ext cx="48888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G/D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603760" y="217476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351320" y="2174760"/>
            <a:ext cx="792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332160" y="2174760"/>
            <a:ext cx="79200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47560" y="2349360"/>
            <a:ext cx="9763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Isolated vir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5603760" y="200016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45.8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351320" y="200016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6 ± 0.11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332160" y="200016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2.47 ± 3.7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647720" y="2000160"/>
            <a:ext cx="1527120" cy="22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/Duck/Hong Kong820/80 (H5N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603760" y="182556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4351320" y="182556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95 ± 2.49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332160" y="182556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11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1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647720" y="1825560"/>
            <a:ext cx="123840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/Japan/434/2003 (H3N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4626000" y="1650960"/>
            <a:ext cx="1825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647720" y="1650960"/>
            <a:ext cx="488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547560" y="1825560"/>
            <a:ext cx="831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ontrol vir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5302080" y="1536840"/>
            <a:ext cx="8780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Relative value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559400" y="1636560"/>
            <a:ext cx="58428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,6 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4105440" y="1347840"/>
            <a:ext cx="534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419640" y="1636560"/>
            <a:ext cx="7045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,3 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776240" y="3395520"/>
            <a:ext cx="48744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1704960" y="2174760"/>
            <a:ext cx="48744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333360" y="21924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33360" y="34146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33360" y="498636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33360" y="673272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33360" y="183816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246480" y="1459080"/>
            <a:ext cx="201456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Association constant (</a:t>
            </a:r>
            <a:r>
              <a:rPr b="0" i="1" lang="ja-JP" sz="7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ja-JP" sz="700" spc="-1" strike="noStrike" baseline="-25000">
                <a:solidFill>
                  <a:srgbClr val="000000"/>
                </a:solidFill>
                <a:latin typeface="Arial"/>
              </a:rPr>
              <a:t>a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lang="ja-JP" sz="7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 sialic acid)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333360" y="146520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1647720" y="1536840"/>
            <a:ext cx="831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Viru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3343320" y="1647720"/>
            <a:ext cx="19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333360" y="795024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351320" y="688356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.16 ±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332160" y="688356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.80 ± 1.17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647720" y="6883560"/>
            <a:ext cx="14652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120N,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,I151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5603760" y="688356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4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351320" y="671040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.27 ± 1.1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332160" y="671040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.22 ± 1.83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647720" y="6710400"/>
            <a:ext cx="14652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, I151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5603760" y="671040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3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5603760" y="77565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6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4351320" y="775656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08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4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332160" y="77565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.16 ± 1.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628640" y="775656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120N,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,I151T,V210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5603760" y="75819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0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351320" y="758196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70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1.0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332160" y="75819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.28 ± 0.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647720" y="7581960"/>
            <a:ext cx="14652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1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,I151T,V210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603760" y="74073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6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351320" y="740736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.40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8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332160" y="74073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52 ± 1.2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1647720" y="7407360"/>
            <a:ext cx="14652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S120N,V210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603760" y="72327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4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351320" y="723276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.31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0.7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332160" y="72327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.58 ± 3.2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647720" y="7232760"/>
            <a:ext cx="97632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V210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47560" y="1536840"/>
            <a:ext cx="831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ategor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50560" y="1104840"/>
            <a:ext cx="414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able S1. Virus binding affinity to sialylglycopolyme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"/>
          <p:cNvSpPr/>
          <p:nvPr/>
        </p:nvSpPr>
        <p:spPr>
          <a:xfrm>
            <a:off x="333360" y="596124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33360" y="665964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33360" y="28177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33360" y="33415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33360" y="369108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33360" y="40402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33360" y="45640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33360" y="49132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33360" y="52624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33360" y="56116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33360" y="29923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33360" y="351648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33360" y="386568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33360" y="42148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33360" y="47386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33360" y="50878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33360" y="54370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33360" y="57862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33360" y="631044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33360" y="683424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33360" y="613584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33360" y="648504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33360" y="700884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33360" y="316692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33360" y="438948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33360" y="718020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4343400" y="69865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3357720" y="69865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55 ± 2.9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628640" y="698652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+129S,T155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4343400" y="68119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9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357720" y="68119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.32 ± 2.8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1628640" y="681192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T155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4343400" y="66387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9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357720" y="66387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35 ± 2.8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1628640" y="663876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+129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343400" y="64753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357720" y="64753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32 ± 2.7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1628640" y="647532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T151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343400" y="62895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04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4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357720" y="62895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56 ± 2.2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628640" y="628956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343400" y="61149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9 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357720" y="61149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24 ± 0.3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1628640" y="611496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203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+129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371840" y="594036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2.81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64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386160" y="59403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1.03 ± 4.32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1628640" y="6475320"/>
            <a:ext cx="4874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1628640" y="6475320"/>
            <a:ext cx="4892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4343400" y="419724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357720" y="419724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08 ± 0.9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1628640" y="419724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482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H192Q,P235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343400" y="40194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11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357720" y="40194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92 ± 3.1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1628640" y="401940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482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P235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4343400" y="384804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3357720" y="384804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.70 ± 4.1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1628640" y="384804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482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H192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371840" y="3673440"/>
            <a:ext cx="792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2.84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 0.3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386160" y="367344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0.37 ± 1.5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1628640" y="3673440"/>
            <a:ext cx="97632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rEG/D1-EG/482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343400" y="56833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3357720" y="568332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628640" y="5683320"/>
            <a:ext cx="4874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628640" y="5683320"/>
            <a:ext cx="4892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1628640" y="4024440"/>
            <a:ext cx="487440" cy="19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4343400" y="55911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357720" y="559116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23 ± 1.8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628640" y="559116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+129S,T151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4343400" y="54198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3357720" y="54198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36 ± 3.2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628640" y="541980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T151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343400" y="52434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0.0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3357720" y="52434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.38 ± 2.7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628640" y="5243400"/>
            <a:ext cx="187164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,+129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4343400" y="50688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2 ±0.0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357720" y="50688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.22 ± 1.1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1628640" y="506880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T151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4343400" y="48942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60 ±0.7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357720" y="48942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.23 ± 2.1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1628640" y="489420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N120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4343400" y="47196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4 ± 0.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357720" y="47196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.96 ± 0.8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1628640" y="4719600"/>
            <a:ext cx="14655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0929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+129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4349880" y="45450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3.41 ±1.4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386160" y="4545000"/>
            <a:ext cx="79200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0.18 ± 2.9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1628640" y="4545000"/>
            <a:ext cx="97632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rEG/D1-EG/0929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33360" y="2622600"/>
            <a:ext cx="6118200" cy="162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33360" y="2451240"/>
            <a:ext cx="6118200" cy="161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5599080" y="698652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54.5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5599080" y="681192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0.6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5599080" y="66387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5.5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5599080" y="647532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32.1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5599080" y="62895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48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5599080" y="61149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6.57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5627520" y="59403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3.91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5599080" y="419724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8.4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5599080" y="40194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.1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5599080" y="384804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69.6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5627520" y="367344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3.65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5599080" y="568332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5599080" y="559116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23.0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5599080" y="54198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36.1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5599080" y="52434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437.93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5599080" y="50688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29.49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5599080" y="48942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5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5599080" y="47196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33.1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5627520" y="4545000"/>
            <a:ext cx="57636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2.9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5599080" y="698652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1628640" y="628956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1628640" y="5418000"/>
            <a:ext cx="57636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637160" y="2625840"/>
            <a:ext cx="1825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1628640" y="2625840"/>
            <a:ext cx="4892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5297400" y="2519280"/>
            <a:ext cx="8780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Relative value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4551480" y="2611440"/>
            <a:ext cx="5839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,6 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456080" y="2322360"/>
            <a:ext cx="182520" cy="1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spcBef>
                <a:spcPts val="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444840" y="2611440"/>
            <a:ext cx="7048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,3 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33360" y="281304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3219480" y="2433600"/>
            <a:ext cx="201600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Association constant (</a:t>
            </a:r>
            <a:r>
              <a:rPr b="0" i="1" lang="ja-JP" sz="7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ja-JP" sz="700" spc="-1" strike="noStrike" baseline="-25000">
                <a:solidFill>
                  <a:srgbClr val="000000"/>
                </a:solidFill>
                <a:latin typeface="Arial"/>
              </a:rPr>
              <a:t>a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lang="ja-JP" sz="7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</a:rPr>
              <a:t> sialic acid)</a:t>
            </a:r>
            <a:r>
              <a:rPr b="0" lang="ja-JP" sz="7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333360" y="2440080"/>
            <a:ext cx="61200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1628640" y="2519280"/>
            <a:ext cx="831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Viru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3328920" y="2622600"/>
            <a:ext cx="190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428760" y="280044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combinant viru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4343400" y="33242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07 ± 0.1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3357720" y="33242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.09 ± 4.2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1628640" y="3324240"/>
            <a:ext cx="1465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1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H192Q,P235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4343400" y="31496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.72 ± 2.4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3357720" y="31496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.10 ± 1.66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1628640" y="3149640"/>
            <a:ext cx="1465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1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P235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4343400" y="29750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.12 ± 0.21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3357720" y="29750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.65 ± 2.73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1628640" y="2975040"/>
            <a:ext cx="1465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EG/D1-EG/1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H192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5599080" y="33242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9.92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5599080" y="31496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5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5599080" y="29750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0.55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5627520" y="2800440"/>
            <a:ext cx="576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3.27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4371840" y="2800440"/>
            <a:ext cx="792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4.74 ± 1.98)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3386160" y="2800440"/>
            <a:ext cx="792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15.55 ± 3.29)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1628640" y="2800440"/>
            <a:ext cx="976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rEG/D1-EG/1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1628640" y="5940360"/>
            <a:ext cx="976320" cy="19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(rEG/D1-EG/2039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428760" y="2519280"/>
            <a:ext cx="831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ategor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428760" y="2975040"/>
            <a:ext cx="912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(continued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276120" y="7291440"/>
            <a:ext cx="599616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 Dose-response curves of virus binding to the sialic acid (SA) were analyzed using a single site binding algorithm and curve fitting by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GraphPad Prism to determine the association constant values (</a:t>
            </a:r>
            <a:r>
              <a:rPr b="1" i="1" lang="ja-JP" sz="7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1" lang="ja-JP" sz="700" spc="-1" strike="noStrike" baseline="-25000">
                <a:solidFill>
                  <a:srgbClr val="000000"/>
                </a:solidFill>
                <a:latin typeface="Arial"/>
              </a:rPr>
              <a:t>a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)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333720" y="7674120"/>
            <a:ext cx="4278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 baseline="30000">
                <a:solidFill>
                  <a:srgbClr val="000000"/>
                </a:solidFill>
                <a:latin typeface="Arial"/>
              </a:rPr>
              <a:t>b 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Each value is the mean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 SD of three to six experiments, which were each performed in triplicate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314640" y="7948440"/>
            <a:ext cx="3999600" cy="21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r>
              <a:rPr b="1" i="1" lang="ja-JP" sz="7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1" lang="ja-JP" sz="700" spc="-1" strike="noStrike" baseline="-25000">
                <a:solidFill>
                  <a:srgbClr val="000000"/>
                </a:solidFill>
                <a:latin typeface="Arial"/>
              </a:rPr>
              <a:t>a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ja-JP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2,3 SA)/</a:t>
            </a:r>
            <a:r>
              <a:rPr b="1" i="1" lang="ja-JP" sz="7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1" lang="ja-JP" sz="700" spc="-1" strike="noStrike" baseline="-25000">
                <a:solidFill>
                  <a:srgbClr val="000000"/>
                </a:solidFill>
                <a:latin typeface="Arial"/>
              </a:rPr>
              <a:t>a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ja-JP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2,6 SA), lower relative values reflect higher binding specificity to </a:t>
            </a:r>
            <a:r>
              <a:rPr b="1" lang="ja-JP" sz="7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ja-JP" sz="700" spc="-1" strike="noStrike">
                <a:solidFill>
                  <a:srgbClr val="000000"/>
                </a:solidFill>
                <a:latin typeface="Arial"/>
              </a:rPr>
              <a:t>2,6 SA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51640" y="2028960"/>
            <a:ext cx="501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able S1 (</a:t>
            </a:r>
            <a:r>
              <a:rPr b="1" i="1" lang="ja-JP" sz="1200" spc="-1" strike="noStrike">
                <a:solidFill>
                  <a:srgbClr val="000000"/>
                </a:solidFill>
                <a:latin typeface="Arial"/>
              </a:rPr>
              <a:t>continued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). Virus binding affinity to sialylglycopolyme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09:12:28Z</dcterms:created>
  <dc:creator>nabe</dc:creator>
  <dc:description/>
  <dc:language>en-US</dc:language>
  <cp:lastModifiedBy>nabe</cp:lastModifiedBy>
  <dcterms:modified xsi:type="dcterms:W3CDTF">2011-03-25T07:55:31Z</dcterms:modified>
  <cp:revision>111</cp:revision>
  <dc:subject/>
  <dc:title>スライド 1</dc:title>
</cp:coreProperties>
</file>